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02_E6D88350.xml" ContentType="application/vnd.ms-powerpoint.comments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D331739-B77A-3EA2-3348-FBEF4ADBC5B9}" name="Nikki Schultz" initials="" userId="S::Nikki.Schultz@telethonkids.org.au::cc73c5d7-b091-4f9e-aaf8-bd7edf096bd3" providerId="AD"/>
  <p188:author id="{F83D7754-1C2D-0384-E301-5F412CF497CB}" name="David Martino" initials="DM" userId="S::david.martino@telethonkids.org.au::416574d3-8ff8-4022-be61-3276c04e9eb0" providerId="AD"/>
  <p188:author id="{7F88456E-E186-8E03-EAA1-0C85E940BE3E}" name="Nikki Schultz" initials="NS" userId="S::nikki.schultz@telethonkids.org.au::cc73c5d7-b091-4f9e-aaf8-bd7edf096bd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1633A0F-B6CA-0BE1-7D74-9057E54708CB}" v="11" dt="2024-05-19T10:16:21.202"/>
    <p1510:client id="{9DA7DCA3-CDC1-4826-ACF9-7758AE7CC640}" v="2" dt="2024-05-20T02:34:56.1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1"/>
    <p:restoredTop sz="94789"/>
  </p:normalViewPr>
  <p:slideViewPr>
    <p:cSldViewPr snapToGrid="0" snapToObjects="1">
      <p:cViewPr varScale="1">
        <p:scale>
          <a:sx n="70" d="100"/>
          <a:sy n="70" d="100"/>
        </p:scale>
        <p:origin x="22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Martino" userId="S::david.martino@telethonkids.org.au::416574d3-8ff8-4022-be61-3276c04e9eb0" providerId="AD" clId="Web-{29EC65AD-0995-4B15-8450-A303C3BFC93B}"/>
    <pc:docChg chg="mod">
      <pc:chgData name="David Martino" userId="S::david.martino@telethonkids.org.au::416574d3-8ff8-4022-be61-3276c04e9eb0" providerId="AD" clId="Web-{29EC65AD-0995-4B15-8450-A303C3BFC93B}" dt="2024-05-17T08:54:32.850" v="2"/>
      <pc:docMkLst>
        <pc:docMk/>
      </pc:docMkLst>
      <pc:sldChg chg="addCm">
        <pc:chgData name="David Martino" userId="S::david.martino@telethonkids.org.au::416574d3-8ff8-4022-be61-3276c04e9eb0" providerId="AD" clId="Web-{29EC65AD-0995-4B15-8450-A303C3BFC93B}" dt="2024-05-17T08:54:32.850" v="2"/>
        <pc:sldMkLst>
          <pc:docMk/>
          <pc:sldMk cId="3872949072" sldId="258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David Martino" userId="S::david.martino@telethonkids.org.au::416574d3-8ff8-4022-be61-3276c04e9eb0" providerId="AD" clId="Web-{29EC65AD-0995-4B15-8450-A303C3BFC93B}" dt="2024-05-17T08:54:32.850" v="2"/>
              <pc2:cmMkLst xmlns:pc2="http://schemas.microsoft.com/office/powerpoint/2019/9/main/command">
                <pc:docMk/>
                <pc:sldMk cId="3872949072" sldId="258"/>
                <pc2:cmMk id="{ADF2AB37-4799-49DA-9235-43AD989EC7F3}"/>
              </pc2:cmMkLst>
            </pc226:cmChg>
          </p:ext>
        </pc:extLst>
      </pc:sldChg>
    </pc:docChg>
  </pc:docChgLst>
  <pc:docChgLst>
    <pc:chgData name="Nikki Schultz" userId="S::nikki.schultz@telethonkids.org.au::cc73c5d7-b091-4f9e-aaf8-bd7edf096bd3" providerId="AD" clId="Web-{71633A0F-B6CA-0BE1-7D74-9057E54708CB}"/>
    <pc:docChg chg="mod modSld">
      <pc:chgData name="Nikki Schultz" userId="S::nikki.schultz@telethonkids.org.au::cc73c5d7-b091-4f9e-aaf8-bd7edf096bd3" providerId="AD" clId="Web-{71633A0F-B6CA-0BE1-7D74-9057E54708CB}" dt="2024-05-19T10:16:21.202" v="6"/>
      <pc:docMkLst>
        <pc:docMk/>
      </pc:docMkLst>
      <pc:sldChg chg="addSp delSp modSp modCm">
        <pc:chgData name="Nikki Schultz" userId="S::nikki.schultz@telethonkids.org.au::cc73c5d7-b091-4f9e-aaf8-bd7edf096bd3" providerId="AD" clId="Web-{71633A0F-B6CA-0BE1-7D74-9057E54708CB}" dt="2024-05-19T10:16:21.202" v="6"/>
        <pc:sldMkLst>
          <pc:docMk/>
          <pc:sldMk cId="3872949072" sldId="258"/>
        </pc:sldMkLst>
        <pc:spChg chg="mod">
          <ac:chgData name="Nikki Schultz" userId="S::nikki.schultz@telethonkids.org.au::cc73c5d7-b091-4f9e-aaf8-bd7edf096bd3" providerId="AD" clId="Web-{71633A0F-B6CA-0BE1-7D74-9057E54708CB}" dt="2024-05-19T10:15:53.030" v="4" actId="20577"/>
          <ac:spMkLst>
            <pc:docMk/>
            <pc:sldMk cId="3872949072" sldId="258"/>
            <ac:spMk id="6" creationId="{F9EAD4FE-2A8C-DD4F-BCF8-F62144D9E105}"/>
          </ac:spMkLst>
        </pc:spChg>
        <pc:picChg chg="add mod">
          <ac:chgData name="Nikki Schultz" userId="S::nikki.schultz@telethonkids.org.au::cc73c5d7-b091-4f9e-aaf8-bd7edf096bd3" providerId="AD" clId="Web-{71633A0F-B6CA-0BE1-7D74-9057E54708CB}" dt="2024-05-19T10:15:48.998" v="3" actId="1076"/>
          <ac:picMkLst>
            <pc:docMk/>
            <pc:sldMk cId="3872949072" sldId="258"/>
            <ac:picMk id="2" creationId="{920FAAC3-1644-1E7E-EB05-68FA07574612}"/>
          </ac:picMkLst>
        </pc:picChg>
        <pc:picChg chg="del">
          <ac:chgData name="Nikki Schultz" userId="S::nikki.schultz@telethonkids.org.au::cc73c5d7-b091-4f9e-aaf8-bd7edf096bd3" providerId="AD" clId="Web-{71633A0F-B6CA-0BE1-7D74-9057E54708CB}" dt="2024-05-19T10:12:51.073" v="0"/>
          <ac:picMkLst>
            <pc:docMk/>
            <pc:sldMk cId="3872949072" sldId="258"/>
            <ac:picMk id="7" creationId="{9843C35E-4880-CA4D-BDFC-9FC7380BA37A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">
              <pc226:chgData name="Nikki Schultz" userId="S::nikki.schultz@telethonkids.org.au::cc73c5d7-b091-4f9e-aaf8-bd7edf096bd3" providerId="AD" clId="Web-{71633A0F-B6CA-0BE1-7D74-9057E54708CB}" dt="2024-05-19T10:16:21.202" v="6"/>
              <pc2:cmMkLst xmlns:pc2="http://schemas.microsoft.com/office/powerpoint/2019/9/main/command">
                <pc:docMk/>
                <pc:sldMk cId="3872949072" sldId="258"/>
                <pc2:cmMk id="{ADF2AB37-4799-49DA-9235-43AD989EC7F3}"/>
              </pc2:cmMkLst>
              <pc226:cmRplyChg chg="add">
                <pc226:chgData name="Nikki Schultz" userId="S::nikki.schultz@telethonkids.org.au::cc73c5d7-b091-4f9e-aaf8-bd7edf096bd3" providerId="AD" clId="Web-{71633A0F-B6CA-0BE1-7D74-9057E54708CB}" dt="2024-05-19T10:16:21.202" v="6"/>
                <pc2:cmRplyMkLst xmlns:pc2="http://schemas.microsoft.com/office/powerpoint/2019/9/main/command">
                  <pc:docMk/>
                  <pc:sldMk cId="3872949072" sldId="258"/>
                  <pc2:cmMk id="{ADF2AB37-4799-49DA-9235-43AD989EC7F3}"/>
                  <pc2:cmRplyMk id="{15D582BF-B7CE-4C11-9F46-D4D04D5CB5D3}"/>
                </pc2:cmRplyMkLst>
              </pc226:cmRplyChg>
            </pc226:cmChg>
          </p:ext>
        </pc:extLst>
      </pc:sldChg>
    </pc:docChg>
  </pc:docChgLst>
  <pc:docChgLst>
    <pc:chgData name="David Martino" userId="416574d3-8ff8-4022-be61-3276c04e9eb0" providerId="ADAL" clId="{C2A2EECA-B6D9-0449-8305-E4A5C110B44F}"/>
    <pc:docChg chg="custSel addSld modSld">
      <pc:chgData name="David Martino" userId="416574d3-8ff8-4022-be61-3276c04e9eb0" providerId="ADAL" clId="{C2A2EECA-B6D9-0449-8305-E4A5C110B44F}" dt="2023-09-15T04:35:04.261" v="288" actId="20577"/>
      <pc:docMkLst>
        <pc:docMk/>
      </pc:docMkLst>
      <pc:sldChg chg="modSp mod">
        <pc:chgData name="David Martino" userId="416574d3-8ff8-4022-be61-3276c04e9eb0" providerId="ADAL" clId="{C2A2EECA-B6D9-0449-8305-E4A5C110B44F}" dt="2023-09-15T04:33:01.209" v="2" actId="20577"/>
        <pc:sldMkLst>
          <pc:docMk/>
          <pc:sldMk cId="3367758796" sldId="256"/>
        </pc:sldMkLst>
        <pc:spChg chg="mod">
          <ac:chgData name="David Martino" userId="416574d3-8ff8-4022-be61-3276c04e9eb0" providerId="ADAL" clId="{C2A2EECA-B6D9-0449-8305-E4A5C110B44F}" dt="2023-09-15T04:33:01.209" v="2" actId="20577"/>
          <ac:spMkLst>
            <pc:docMk/>
            <pc:sldMk cId="3367758796" sldId="256"/>
            <ac:spMk id="5" creationId="{EE411031-0BF5-8C4A-AAE2-BFBF8499ED36}"/>
          </ac:spMkLst>
        </pc:spChg>
      </pc:sldChg>
      <pc:sldChg chg="addSp delSp modSp new mod">
        <pc:chgData name="David Martino" userId="416574d3-8ff8-4022-be61-3276c04e9eb0" providerId="ADAL" clId="{C2A2EECA-B6D9-0449-8305-E4A5C110B44F}" dt="2023-09-15T04:35:04.261" v="288" actId="20577"/>
        <pc:sldMkLst>
          <pc:docMk/>
          <pc:sldMk cId="3872949072" sldId="258"/>
        </pc:sldMkLst>
        <pc:spChg chg="del">
          <ac:chgData name="David Martino" userId="416574d3-8ff8-4022-be61-3276c04e9eb0" providerId="ADAL" clId="{C2A2EECA-B6D9-0449-8305-E4A5C110B44F}" dt="2023-09-15T04:33:12.126" v="5" actId="478"/>
          <ac:spMkLst>
            <pc:docMk/>
            <pc:sldMk cId="3872949072" sldId="258"/>
            <ac:spMk id="2" creationId="{6E14B780-E491-224F-A1EB-F105629F316D}"/>
          </ac:spMkLst>
        </pc:spChg>
        <pc:spChg chg="del">
          <ac:chgData name="David Martino" userId="416574d3-8ff8-4022-be61-3276c04e9eb0" providerId="ADAL" clId="{C2A2EECA-B6D9-0449-8305-E4A5C110B44F}" dt="2023-09-15T04:33:10.926" v="4" actId="478"/>
          <ac:spMkLst>
            <pc:docMk/>
            <pc:sldMk cId="3872949072" sldId="258"/>
            <ac:spMk id="3" creationId="{CAF16893-837C-0846-9606-16E5D7D087BE}"/>
          </ac:spMkLst>
        </pc:spChg>
        <pc:spChg chg="add mod">
          <ac:chgData name="David Martino" userId="416574d3-8ff8-4022-be61-3276c04e9eb0" providerId="ADAL" clId="{C2A2EECA-B6D9-0449-8305-E4A5C110B44F}" dt="2023-09-15T04:35:04.261" v="288" actId="20577"/>
          <ac:spMkLst>
            <pc:docMk/>
            <pc:sldMk cId="3872949072" sldId="258"/>
            <ac:spMk id="6" creationId="{F9EAD4FE-2A8C-DD4F-BCF8-F62144D9E105}"/>
          </ac:spMkLst>
        </pc:spChg>
        <pc:picChg chg="add mod">
          <ac:chgData name="David Martino" userId="416574d3-8ff8-4022-be61-3276c04e9eb0" providerId="ADAL" clId="{C2A2EECA-B6D9-0449-8305-E4A5C110B44F}" dt="2023-09-15T04:33:25.286" v="10" actId="1076"/>
          <ac:picMkLst>
            <pc:docMk/>
            <pc:sldMk cId="3872949072" sldId="258"/>
            <ac:picMk id="5" creationId="{10DA99E4-4FCF-3D40-8224-4F5D7F4B7EB8}"/>
          </ac:picMkLst>
        </pc:picChg>
      </pc:sldChg>
    </pc:docChg>
  </pc:docChgLst>
  <pc:docChgLst>
    <pc:chgData name="David Martino" userId="S::david.martino@telethonkids.org.au::416574d3-8ff8-4022-be61-3276c04e9eb0" providerId="AD" clId="Web-{9DA7DCA3-CDC1-4826-ACF9-7758AE7CC640}"/>
    <pc:docChg chg="">
      <pc:chgData name="David Martino" userId="S::david.martino@telethonkids.org.au::416574d3-8ff8-4022-be61-3276c04e9eb0" providerId="AD" clId="Web-{9DA7DCA3-CDC1-4826-ACF9-7758AE7CC640}" dt="2024-05-20T02:34:56.127" v="1"/>
      <pc:docMkLst>
        <pc:docMk/>
      </pc:docMkLst>
      <pc:sldChg chg="modCm">
        <pc:chgData name="David Martino" userId="S::david.martino@telethonkids.org.au::416574d3-8ff8-4022-be61-3276c04e9eb0" providerId="AD" clId="Web-{9DA7DCA3-CDC1-4826-ACF9-7758AE7CC640}" dt="2024-05-20T02:34:56.127" v="1"/>
        <pc:sldMkLst>
          <pc:docMk/>
          <pc:sldMk cId="3872949072" sldId="258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mod modRxn">
              <pc226:chgData name="David Martino" userId="S::david.martino@telethonkids.org.au::416574d3-8ff8-4022-be61-3276c04e9eb0" providerId="AD" clId="Web-{9DA7DCA3-CDC1-4826-ACF9-7758AE7CC640}" dt="2024-05-20T02:34:56.127" v="1"/>
              <pc2:cmMkLst xmlns:pc2="http://schemas.microsoft.com/office/powerpoint/2019/9/main/command">
                <pc:docMk/>
                <pc:sldMk cId="3872949072" sldId="258"/>
                <pc2:cmMk id="{ADF2AB37-4799-49DA-9235-43AD989EC7F3}"/>
              </pc2:cmMkLst>
            </pc226:cmChg>
          </p:ext>
        </pc:extLst>
      </pc:sldChg>
    </pc:docChg>
  </pc:docChgLst>
  <pc:docChgLst>
    <pc:chgData name="Nikki Schultz" userId="cc73c5d7-b091-4f9e-aaf8-bd7edf096bd3" providerId="ADAL" clId="{F37AA593-85CD-4B62-B22D-4C6E8435F270}"/>
    <pc:docChg chg="custSel modSld">
      <pc:chgData name="Nikki Schultz" userId="cc73c5d7-b091-4f9e-aaf8-bd7edf096bd3" providerId="ADAL" clId="{F37AA593-85CD-4B62-B22D-4C6E8435F270}" dt="2024-05-14T05:19:01.726" v="10" actId="27614"/>
      <pc:docMkLst>
        <pc:docMk/>
      </pc:docMkLst>
      <pc:sldChg chg="addSp delSp modSp mod">
        <pc:chgData name="Nikki Schultz" userId="cc73c5d7-b091-4f9e-aaf8-bd7edf096bd3" providerId="ADAL" clId="{F37AA593-85CD-4B62-B22D-4C6E8435F270}" dt="2024-05-14T05:19:01.726" v="10" actId="27614"/>
        <pc:sldMkLst>
          <pc:docMk/>
          <pc:sldMk cId="3872949072" sldId="258"/>
        </pc:sldMkLst>
        <pc:spChg chg="mod">
          <ac:chgData name="Nikki Schultz" userId="cc73c5d7-b091-4f9e-aaf8-bd7edf096bd3" providerId="ADAL" clId="{F37AA593-85CD-4B62-B22D-4C6E8435F270}" dt="2024-05-10T05:02:28.489" v="0" actId="20577"/>
          <ac:spMkLst>
            <pc:docMk/>
            <pc:sldMk cId="3872949072" sldId="258"/>
            <ac:spMk id="6" creationId="{F9EAD4FE-2A8C-DD4F-BCF8-F62144D9E105}"/>
          </ac:spMkLst>
        </pc:spChg>
        <pc:picChg chg="add del mod">
          <ac:chgData name="Nikki Schultz" userId="cc73c5d7-b091-4f9e-aaf8-bd7edf096bd3" providerId="ADAL" clId="{F37AA593-85CD-4B62-B22D-4C6E8435F270}" dt="2024-05-14T05:18:50.349" v="6" actId="478"/>
          <ac:picMkLst>
            <pc:docMk/>
            <pc:sldMk cId="3872949072" sldId="258"/>
            <ac:picMk id="3" creationId="{DD482018-9F23-0F36-B6A4-81D44E49181F}"/>
          </ac:picMkLst>
        </pc:picChg>
        <pc:picChg chg="del">
          <ac:chgData name="Nikki Schultz" userId="cc73c5d7-b091-4f9e-aaf8-bd7edf096bd3" providerId="ADAL" clId="{F37AA593-85CD-4B62-B22D-4C6E8435F270}" dt="2024-05-14T05:17:39.456" v="1" actId="478"/>
          <ac:picMkLst>
            <pc:docMk/>
            <pc:sldMk cId="3872949072" sldId="258"/>
            <ac:picMk id="5" creationId="{10DA99E4-4FCF-3D40-8224-4F5D7F4B7EB8}"/>
          </ac:picMkLst>
        </pc:picChg>
        <pc:picChg chg="add mod">
          <ac:chgData name="Nikki Schultz" userId="cc73c5d7-b091-4f9e-aaf8-bd7edf096bd3" providerId="ADAL" clId="{F37AA593-85CD-4B62-B22D-4C6E8435F270}" dt="2024-05-14T05:19:01.726" v="10" actId="27614"/>
          <ac:picMkLst>
            <pc:docMk/>
            <pc:sldMk cId="3872949072" sldId="258"/>
            <ac:picMk id="7" creationId="{9843C35E-4880-CA4D-BDFC-9FC7380BA37A}"/>
          </ac:picMkLst>
        </pc:picChg>
      </pc:sldChg>
    </pc:docChg>
  </pc:docChgLst>
  <pc:docChgLst>
    <pc:chgData name="David Martino" userId="416574d3-8ff8-4022-be61-3276c04e9eb0" providerId="ADAL" clId="{659E81AF-9113-CC42-A740-02C12BD4C064}"/>
    <pc:docChg chg="modSld">
      <pc:chgData name="David Martino" userId="416574d3-8ff8-4022-be61-3276c04e9eb0" providerId="ADAL" clId="{659E81AF-9113-CC42-A740-02C12BD4C064}" dt="2024-02-15T03:45:26.124" v="2" actId="20577"/>
      <pc:docMkLst>
        <pc:docMk/>
      </pc:docMkLst>
      <pc:sldChg chg="modSp mod">
        <pc:chgData name="David Martino" userId="416574d3-8ff8-4022-be61-3276c04e9eb0" providerId="ADAL" clId="{659E81AF-9113-CC42-A740-02C12BD4C064}" dt="2024-02-15T03:45:26.124" v="2" actId="20577"/>
        <pc:sldMkLst>
          <pc:docMk/>
          <pc:sldMk cId="3367758796" sldId="256"/>
        </pc:sldMkLst>
        <pc:spChg chg="mod">
          <ac:chgData name="David Martino" userId="416574d3-8ff8-4022-be61-3276c04e9eb0" providerId="ADAL" clId="{659E81AF-9113-CC42-A740-02C12BD4C064}" dt="2024-02-15T03:45:26.124" v="2" actId="20577"/>
          <ac:spMkLst>
            <pc:docMk/>
            <pc:sldMk cId="3367758796" sldId="256"/>
            <ac:spMk id="5" creationId="{EE411031-0BF5-8C4A-AAE2-BFBF8499ED36}"/>
          </ac:spMkLst>
        </pc:spChg>
      </pc:sldChg>
    </pc:docChg>
  </pc:docChgLst>
</pc:chgInfo>
</file>

<file path=ppt/comments/modernComment_102_E6D88350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ADF2AB37-4799-49DA-9235-43AD989EC7F3}" authorId="{F83D7754-1C2D-0384-E301-5F412CF497CB}" status="resolved" created="2024-05-17T08:54:32.850" startDate="2024-05-17T08:54:32.850" dueDate="2024-05-17T08:54:32.850" assignedTo="{2D331739-B77A-3EA2-3348-FBEF4ADBC5B9}" complete="100000" title="@Nikki Schultz we need to remove the other adjuvant groups that were not reported in the table for this figure.">
    <pc:sldMkLst xmlns:pc="http://schemas.microsoft.com/office/powerpoint/2013/main/command">
      <pc:docMk/>
      <pc:sldMk cId="3872949072" sldId="258"/>
    </pc:sldMkLst>
    <p188:replyLst>
      <p188:reply id="{15D582BF-B7CE-4C11-9F46-D4D04D5CB5D3}" authorId="{7F88456E-E186-8E03-EAA1-0C85E940BE3E}" created="2024-05-19T10:16:21.202">
        <p188:txBody>
          <a:bodyPr/>
          <a:lstStyle/>
          <a:p>
            <a:r>
              <a:rPr lang="en-US"/>
              <a:t>Fixed</a:t>
            </a:r>
          </a:p>
        </p188:txBody>
      </p188:reply>
    </p188:replyLst>
    <p188:txBody>
      <a:bodyPr/>
      <a:lstStyle/>
      <a:p>
        <a:r>
          <a:rPr lang="en-US"/>
          <a:t>[@Nikki Schultz] we need to remove the other adjuvant groups that were not reported in the table for this figure. </a:t>
        </a:r>
      </a:p>
    </p188:txBody>
    <p188:extLst>
      <p:ext xmlns:p="http://schemas.openxmlformats.org/presentationml/2006/main" uri="{5BB2D875-25FF-4072-B9AC-8F64D62656EB}">
        <p228:taskDetails xmlns:p228="http://schemas.microsoft.com/office/powerpoint/2022/08/main">
          <p228:history>
            <p228:event time="2024-05-17T08:54:32.850" id="{6833C41B-FBE1-4764-9DC7-24CF6309C097}">
              <p228:atrbtn authorId="{F83D7754-1C2D-0384-E301-5F412CF497CB}"/>
              <p228:anchr>
                <p228:comment id="{ADF2AB37-4799-49DA-9235-43AD989EC7F3}"/>
              </p228:anchr>
              <p228:add/>
            </p228:event>
            <p228:event time="2024-05-17T08:54:32.850" id="{7181A727-1C6D-4D8E-A745-2094D6926759}">
              <p228:atrbtn authorId="{F83D7754-1C2D-0384-E301-5F412CF497CB}"/>
              <p228:anchr>
                <p228:comment id="{ADF2AB37-4799-49DA-9235-43AD989EC7F3}"/>
              </p228:anchr>
              <p228:asgn authorId="{2D331739-B77A-3EA2-3348-FBEF4ADBC5B9}"/>
            </p228:event>
            <p228:event time="2024-05-17T08:54:32.850" id="{830658DD-EBA5-4B55-80F5-54C5E12BCFF1}">
              <p228:atrbtn authorId="{F83D7754-1C2D-0384-E301-5F412CF497CB}"/>
              <p228:anchr>
                <p228:comment id="{ADF2AB37-4799-49DA-9235-43AD989EC7F3}"/>
              </p228:anchr>
              <p228:title val="@Nikki Schultz we need to remove the other adjuvant groups that were not reported in the table for this figure."/>
            </p228:event>
            <p228:event time="2024-05-17T08:54:32.850" id="{CC4F2942-17D6-422B-8FF7-07165CC9D766}">
              <p228:atrbtn authorId="{F83D7754-1C2D-0384-E301-5F412CF497CB}"/>
              <p228:anchr>
                <p228:comment id="{ADF2AB37-4799-49DA-9235-43AD989EC7F3}"/>
              </p228:anchr>
              <p228:date stDt="2024-05-17T08:54:32.850" endDt="2024-05-17T08:54:32.850"/>
            </p228:event>
            <p228:event time="2024-05-20T02:34:56.127" id="{52C3CD55-5E5A-4E61-BBC1-9FAF80D56FC3}">
              <p228:atrbtn authorId="{F83D7754-1C2D-0384-E301-5F412CF497CB}"/>
              <p228:anchr>
                <p228:comment id="{00000000-0000-0000-0000-000000000000}"/>
              </p228:anchr>
              <p228:pcntCmplt val="100000"/>
            </p228:event>
          </p228:history>
        </p228:taskDetails>
      </p:ext>
      <p:ext xmlns:p="http://schemas.openxmlformats.org/presentationml/2006/main" uri="{57CB4572-C831-44C2-8A1C-0ADB6CCDFE69}">
        <p223:reactions xmlns:p223="http://schemas.microsoft.com/office/powerpoint/2022/03/main">
          <p223:rxn type="👍">
            <p223:instance time="2024-05-20T02:34:52.205" authorId="{F83D7754-1C2D-0384-E301-5F412CF497CB}"/>
          </p223:rxn>
        </p223:reactions>
      </p:ext>
    </p188:extLst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3B5B5-E058-F041-AE84-D5770852BD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D20018-5913-244E-A19B-9B52CD6141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90878-B9F3-7842-A833-58E9235C2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771C4A-7FC6-0F4A-8A81-C6F391A7A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7A472A-7DFC-9E4D-8DE8-E300F159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21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61AFC6-72B6-E94E-836B-1E156A7DDC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939F27-AA9A-104B-B9E5-B6EF1BCD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26061-5A58-D64A-9E06-967CD13D8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6D4C2E-E7C5-D842-BD75-9E511A23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BFA982-93B9-9E4D-9CE3-3FCF781DD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57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49F452-DED1-E044-B19E-17BFB07C5B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81DE6D-85B9-7B49-B84F-2A0F8D286C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0C6B95-DC95-8541-8342-5442F0FAD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C2A9C-2646-0441-A5DD-90BB5F69D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BDB60-C2CB-4C43-BF7E-68C911F14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304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D8980-11A6-2044-B32D-E623A7C852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7A27DD-ABF9-2345-9748-6FFF8ABE37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93E60A-8E37-814D-9375-5B7C1499B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C89A2-5DEC-6C4B-9079-91273409E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7BD413-2761-2940-BB79-05F144174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3BB063-F930-7E48-99F2-ED30FFEA5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C1A7C4-A8FF-D441-B435-4A94364A8C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2FEA18-6E47-D146-9D22-5E7EDF701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820A6E-B3ED-4E4F-B35F-1001F662D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0D9D9-73A4-C44E-95E7-15DA2923B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27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CA5A5-3AF6-644B-8420-C049F8D58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232439-B145-3347-AE3D-431CDFCF7C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5F63DF-1719-C143-AC60-C7E0FFDF81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699866-C872-EB4C-8003-CD2F1D15D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8C71C9-3D03-0D44-8E8B-FDA226AF1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E73FC3-82FA-BA42-A5E0-906174E8A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865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96BD1B-9957-6E4B-B62F-DF5F818ADF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4C4813-9EEE-024C-9C8D-A6FA368838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457AA4-3AA2-394D-B6A8-7415446BE3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D0FB86-3E9C-0844-98DD-33865706B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F614BC-FAAB-504B-9973-5038117FEB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9510AA-DE33-B948-85C9-A6D2FEE98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AC2395-48BF-AD42-8F72-E258B8DC8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5CA872-2460-C041-8EC4-A0FD24F02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1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38258-14BB-1340-B89E-98510952F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ADB06A-174C-154F-BD9C-DF2F9A0E6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ADDD4B-3509-C747-9175-1F6033280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7CBFBE-E4BA-3945-96EE-472BFAFAB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035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C0B768-6290-3C43-B2D6-5667AB90B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5D1545-6CAE-F044-BFF7-9971B7985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FE195C-BADF-AD42-9CEB-1745FA054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02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A9598-6B83-3442-B77C-349AA27C7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A72D49-C761-9942-B177-CD60AD5AA5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A2FF69-2EC2-5B40-94FE-A5C2655C1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9D0642-760B-3A46-A717-A6DD00B9D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45B1FB-DFC4-C24B-AD8A-C104230BA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389B76-2663-2542-9126-8A6F9E07E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827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1D5D1-5195-2540-8437-07F04C1E5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55651E-34E1-A641-8588-D5FD3B634E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BE417E-B8E4-7D42-94D5-A7ED27EDD2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3288E6-B338-E542-92DF-F70E48D2E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5202F9-B8D5-3444-9487-D613F0F0E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66870D-EE86-3549-9D4E-A92FF8DC9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41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14B672-7998-0E43-A35C-AACA495E9B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30AC55-C853-B943-93BF-D89D5C893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F07B58-3D17-4247-A75E-60C64F47FB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7EB64-650E-8943-BD18-9EB240818609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C53815-7BB0-394C-8228-68A36A0622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161BAC-40F6-6A4F-BA22-10CFD89A6E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5F97E-13A2-774D-82AF-34546653DE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46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microsoft.com/office/2018/10/relationships/comments" Target="../comments/modernComment_102_E6D88350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411031-0BF5-8C4A-AAE2-BFBF8499ED36}"/>
              </a:ext>
            </a:extLst>
          </p:cNvPr>
          <p:cNvSpPr txBox="1"/>
          <p:nvPr/>
        </p:nvSpPr>
        <p:spPr>
          <a:xfrm>
            <a:off x="1622996" y="1135784"/>
            <a:ext cx="8946008" cy="22069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8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espiratory Infection- and Asthma-prone, </a:t>
            </a:r>
            <a:r>
              <a:rPr lang="en-US" sz="18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L</a:t>
            </a:r>
            <a:r>
              <a:rPr lang="en-GB" sz="18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ow Vaccine Responder Children</a:t>
            </a:r>
            <a:r>
              <a:rPr lang="en-US" sz="1800" b="1" i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Demonstrate Distinct Mononuclear Cell DNA Methylation Pathways</a:t>
            </a:r>
          </a:p>
          <a:p>
            <a:pPr>
              <a:lnSpc>
                <a:spcPct val="200000"/>
              </a:lnSpc>
              <a:spcAft>
                <a:spcPts val="800"/>
              </a:spcAft>
            </a:pPr>
            <a:endParaRPr lang="en-US" sz="1400" kern="1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4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s</a:t>
            </a:r>
            <a:endParaRPr lang="en-AU" sz="1400" b="1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77587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99456B68-6503-024B-8479-D302E2D53DE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437" y="815546"/>
            <a:ext cx="5838568" cy="46708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F58713A-0717-444A-BC69-CE7454561E91}"/>
              </a:ext>
            </a:extLst>
          </p:cNvPr>
          <p:cNvSpPr txBox="1"/>
          <p:nvPr/>
        </p:nvSpPr>
        <p:spPr>
          <a:xfrm>
            <a:off x="2397210" y="5857788"/>
            <a:ext cx="6882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– Principal component analysis of genetically inferred ancestry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population samples were merged with 1000 Genomes reference populations and PCA analysis performed. Study sample are shown in red. Ellipse denotes the European reference population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7830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9EAD4FE-2A8C-DD4F-BCF8-F62144D9E105}"/>
              </a:ext>
            </a:extLst>
          </p:cNvPr>
          <p:cNvSpPr txBox="1"/>
          <p:nvPr/>
        </p:nvSpPr>
        <p:spPr>
          <a:xfrm>
            <a:off x="2397210" y="5857788"/>
            <a:ext cx="6882714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Figure S2 – Boxplots of inferred blood cell composition. </a:t>
            </a:r>
            <a:r>
              <a:rPr lang="en-US" sz="1200" dirty="0">
                <a:latin typeface="Times New Roman"/>
                <a:cs typeface="Times New Roman"/>
              </a:rPr>
              <a:t>Cell counts were performed using statistical inference as implemented in the </a:t>
            </a:r>
            <a:r>
              <a:rPr lang="en-US" sz="1200" dirty="0" err="1">
                <a:latin typeface="Times New Roman"/>
                <a:cs typeface="Times New Roman"/>
              </a:rPr>
              <a:t>EpiDish</a:t>
            </a:r>
            <a:r>
              <a:rPr lang="en-US" sz="1200" dirty="0">
                <a:latin typeface="Times New Roman"/>
                <a:cs typeface="Times New Roman"/>
              </a:rPr>
              <a:t> R package. Boxplots show mean and standard deviation. </a:t>
            </a:r>
            <a:r>
              <a:rPr lang="en-US" sz="1200" i="1" dirty="0">
                <a:latin typeface="Times New Roman"/>
                <a:cs typeface="Times New Roman"/>
              </a:rPr>
              <a:t>IAP- Infection allergy/asthma prone, NIAP = Non infection allergy, asthma prone.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pic>
        <p:nvPicPr>
          <p:cNvPr id="2" name="Picture 1" descr="A screenshot of a graph&#10;&#10;Description automatically generated">
            <a:extLst>
              <a:ext uri="{FF2B5EF4-FFF2-40B4-BE49-F238E27FC236}">
                <a16:creationId xmlns:a16="http://schemas.microsoft.com/office/drawing/2014/main" id="{920FAAC3-1644-1E7E-EB05-68FA075746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7751" y="359080"/>
            <a:ext cx="5200389" cy="5137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949072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1be9302-b96a-4f5b-b0c3-3c25ae7bdbf3">
      <Terms xmlns="http://schemas.microsoft.com/office/infopath/2007/PartnerControls"/>
    </lcf76f155ced4ddcb4097134ff3c332f>
    <TaxCatchAll xmlns="cf1263a7-f6c1-49ac-ad55-0bd93531e630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DE0E84DB3CB8C4DBD2004B450D01151" ma:contentTypeVersion="12" ma:contentTypeDescription="Create a new document." ma:contentTypeScope="" ma:versionID="5434c70be380adaf658401848cdc11f4">
  <xsd:schema xmlns:xsd="http://www.w3.org/2001/XMLSchema" xmlns:xs="http://www.w3.org/2001/XMLSchema" xmlns:p="http://schemas.microsoft.com/office/2006/metadata/properties" xmlns:ns2="b1be9302-b96a-4f5b-b0c3-3c25ae7bdbf3" xmlns:ns3="cf1263a7-f6c1-49ac-ad55-0bd93531e630" targetNamespace="http://schemas.microsoft.com/office/2006/metadata/properties" ma:root="true" ma:fieldsID="2e543562c209aa7ad57c44e1d7390bf2" ns2:_="" ns3:_="">
    <xsd:import namespace="b1be9302-b96a-4f5b-b0c3-3c25ae7bdbf3"/>
    <xsd:import namespace="cf1263a7-f6c1-49ac-ad55-0bd93531e63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1be9302-b96a-4f5b-b0c3-3c25ae7bdbf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2" nillable="true" ma:taxonomy="true" ma:internalName="lcf76f155ced4ddcb4097134ff3c332f" ma:taxonomyFieldName="MediaServiceImageTags" ma:displayName="Image Tags" ma:readOnly="false" ma:fieldId="{5cf76f15-5ced-4ddc-b409-7134ff3c332f}" ma:taxonomyMulti="true" ma:sspId="a07d500a-1631-415a-bac3-7f3300fd82a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1263a7-f6c1-49ac-ad55-0bd93531e630" elementFormDefault="qualified">
    <xsd:import namespace="http://schemas.microsoft.com/office/2006/documentManagement/types"/>
    <xsd:import namespace="http://schemas.microsoft.com/office/infopath/2007/PartnerControls"/>
    <xsd:element name="TaxCatchAll" ma:index="13" nillable="true" ma:displayName="Taxonomy Catch All Column" ma:hidden="true" ma:list="{bfa3a2af-e754-4ba8-9b34-5186f80378f7}" ma:internalName="TaxCatchAll" ma:showField="CatchAllData" ma:web="cf1263a7-f6c1-49ac-ad55-0bd93531e63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E5B5A10-3C24-443A-8DF7-B20675B23F7B}">
  <ds:schemaRefs>
    <ds:schemaRef ds:uri="http://purl.org/dc/terms/"/>
    <ds:schemaRef ds:uri="http://purl.org/dc/elements/1.1/"/>
    <ds:schemaRef ds:uri="http://schemas.microsoft.com/office/2006/documentManagement/types"/>
    <ds:schemaRef ds:uri="4724958b-0591-412c-b043-474dd89be71e"/>
    <ds:schemaRef ds:uri="http://www.w3.org/XML/1998/namespace"/>
    <ds:schemaRef ds:uri="http://purl.org/dc/dcmitype/"/>
    <ds:schemaRef ds:uri="aa2fd143-0a6f-4ca3-88fc-98718013ef82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15F50C72-7A60-4D5D-B9F7-E27F1BD878A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395836E-9A39-4763-BD58-5FEEED0B6BDF}"/>
</file>

<file path=docProps/app.xml><?xml version="1.0" encoding="utf-8"?>
<Properties xmlns="http://schemas.openxmlformats.org/officeDocument/2006/extended-properties" xmlns:vt="http://schemas.openxmlformats.org/officeDocument/2006/docPropsVTypes">
  <TotalTime>330</TotalTime>
  <Words>107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Martino</dc:creator>
  <cp:lastModifiedBy>Nikki Schultz</cp:lastModifiedBy>
  <cp:revision>9</cp:revision>
  <dcterms:created xsi:type="dcterms:W3CDTF">2023-09-14T07:22:05Z</dcterms:created>
  <dcterms:modified xsi:type="dcterms:W3CDTF">2024-05-20T02:3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DE0E84DB3CB8C4DBD2004B450D01151</vt:lpwstr>
  </property>
  <property fmtid="{D5CDD505-2E9C-101B-9397-08002B2CF9AE}" pid="3" name="MediaServiceImageTags">
    <vt:lpwstr/>
  </property>
</Properties>
</file>